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71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dhuravasal Krishnan, Janani (jananimk)" userId="6969b20d-d298-4095-ade9-5a3c5ff7904a" providerId="ADAL" clId="{58253F35-F98A-46DE-96B1-DA6A6669306D}"/>
    <pc:docChg chg="addSld delSld modSld">
      <pc:chgData name="Madhuravasal Krishnan, Janani (jananimk)" userId="6969b20d-d298-4095-ade9-5a3c5ff7904a" providerId="ADAL" clId="{58253F35-F98A-46DE-96B1-DA6A6669306D}" dt="2024-06-12T20:11:29.947" v="24" actId="20577"/>
      <pc:docMkLst>
        <pc:docMk/>
      </pc:docMkLst>
      <pc:sldChg chg="modSp add">
        <pc:chgData name="Madhuravasal Krishnan, Janani (jananimk)" userId="6969b20d-d298-4095-ade9-5a3c5ff7904a" providerId="ADAL" clId="{58253F35-F98A-46DE-96B1-DA6A6669306D}" dt="2024-06-12T20:11:29.947" v="24" actId="20577"/>
        <pc:sldMkLst>
          <pc:docMk/>
          <pc:sldMk cId="1794106112" sldId="259"/>
        </pc:sldMkLst>
        <pc:spChg chg="mod">
          <ac:chgData name="Madhuravasal Krishnan, Janani (jananimk)" userId="6969b20d-d298-4095-ade9-5a3c5ff7904a" providerId="ADAL" clId="{58253F35-F98A-46DE-96B1-DA6A6669306D}" dt="2024-06-12T20:11:29.947" v="24" actId="20577"/>
          <ac:spMkLst>
            <pc:docMk/>
            <pc:sldMk cId="1794106112" sldId="259"/>
            <ac:spMk id="6" creationId="{F39602F5-79C1-4376-9377-27E1F7C1D53D}"/>
          </ac:spMkLst>
        </pc:spChg>
      </pc:sldChg>
    </pc:docChg>
  </pc:docChgLst>
  <pc:docChgLst>
    <pc:chgData name="Madhuravasal Krishnan, Janani (jananimk)" userId="6969b20d-d298-4095-ade9-5a3c5ff7904a" providerId="ADAL" clId="{CEE57AA8-7B94-462E-B0B0-71812B200962}"/>
    <pc:docChg chg="modSld">
      <pc:chgData name="Madhuravasal Krishnan, Janani (jananimk)" userId="6969b20d-d298-4095-ade9-5a3c5ff7904a" providerId="ADAL" clId="{CEE57AA8-7B94-462E-B0B0-71812B200962}" dt="2024-07-11T18:37:48.409" v="50" actId="123"/>
      <pc:docMkLst>
        <pc:docMk/>
      </pc:docMkLst>
      <pc:sldChg chg="modSp">
        <pc:chgData name="Madhuravasal Krishnan, Janani (jananimk)" userId="6969b20d-d298-4095-ade9-5a3c5ff7904a" providerId="ADAL" clId="{CEE57AA8-7B94-462E-B0B0-71812B200962}" dt="2024-07-11T18:37:48.409" v="50" actId="123"/>
        <pc:sldMkLst>
          <pc:docMk/>
          <pc:sldMk cId="1794106112" sldId="259"/>
        </pc:sldMkLst>
        <pc:spChg chg="mod">
          <ac:chgData name="Madhuravasal Krishnan, Janani (jananimk)" userId="6969b20d-d298-4095-ade9-5a3c5ff7904a" providerId="ADAL" clId="{CEE57AA8-7B94-462E-B0B0-71812B200962}" dt="2024-07-11T18:37:48.409" v="50" actId="123"/>
          <ac:spMkLst>
            <pc:docMk/>
            <pc:sldMk cId="1794106112" sldId="259"/>
            <ac:spMk id="6" creationId="{F39602F5-79C1-4376-9377-27E1F7C1D53D}"/>
          </ac:spMkLst>
        </pc:spChg>
        <pc:graphicFrameChg chg="mod">
          <ac:chgData name="Madhuravasal Krishnan, Janani (jananimk)" userId="6969b20d-d298-4095-ade9-5a3c5ff7904a" providerId="ADAL" clId="{CEE57AA8-7B94-462E-B0B0-71812B200962}" dt="2024-07-11T18:36:57.235" v="47" actId="1036"/>
          <ac:graphicFrameMkLst>
            <pc:docMk/>
            <pc:sldMk cId="1794106112" sldId="259"/>
            <ac:graphicFrameMk id="7" creationId="{AAB57179-6645-41A8-AF74-F807E683A180}"/>
          </ac:graphicFrameMkLst>
        </pc:graphicFrameChg>
        <pc:graphicFrameChg chg="mod">
          <ac:chgData name="Madhuravasal Krishnan, Janani (jananimk)" userId="6969b20d-d298-4095-ade9-5a3c5ff7904a" providerId="ADAL" clId="{CEE57AA8-7B94-462E-B0B0-71812B200962}" dt="2024-07-11T18:36:52.032" v="46" actId="1035"/>
          <ac:graphicFrameMkLst>
            <pc:docMk/>
            <pc:sldMk cId="1794106112" sldId="259"/>
            <ac:graphicFrameMk id="8" creationId="{8C9DB45E-1755-4B33-B35E-2836FFACA1C2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mailuc-my.sharepoint.com/personal/jananimk_ucmail_uc_edu/Documents/202/2023/T%20cell%20isolation/Day%203-%20p24%20ELISA%20and%20pol%20genePCR%20results%20(project%20control%2073)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mailuc-my.sharepoint.com/personal/jananimk_ucmail_uc_edu/Documents/202/2023/T%20cell%20isolation/PCR%20results%20for%20controls%2063,66,37,62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70253718285214"/>
          <c:y val="5.6632040994351991E-2"/>
          <c:w val="0.76982648002333043"/>
          <c:h val="0.4776215158155908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ay 3 C37'!$J$14:$J$17</c:f>
                <c:numCache>
                  <c:formatCode>General</c:formatCode>
                  <c:ptCount val="4"/>
                  <c:pt idx="0">
                    <c:v>0.37266129138385939</c:v>
                  </c:pt>
                  <c:pt idx="1">
                    <c:v>0.93165322845964593</c:v>
                  </c:pt>
                  <c:pt idx="2">
                    <c:v>2.4222983939950837</c:v>
                  </c:pt>
                  <c:pt idx="3">
                    <c:v>0.74532258276771879</c:v>
                  </c:pt>
                </c:numCache>
              </c:numRef>
            </c:plus>
            <c:minus>
              <c:numRef>
                <c:f>'Day 3 C37'!$J$14:$J$17</c:f>
                <c:numCache>
                  <c:formatCode>General</c:formatCode>
                  <c:ptCount val="4"/>
                  <c:pt idx="0">
                    <c:v>0.37266129138385939</c:v>
                  </c:pt>
                  <c:pt idx="1">
                    <c:v>0.93165322845964593</c:v>
                  </c:pt>
                  <c:pt idx="2">
                    <c:v>2.4222983939950837</c:v>
                  </c:pt>
                  <c:pt idx="3">
                    <c:v>0.7453225827677187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ay 3 C37'!$D$14:$D$17</c:f>
              <c:strCache>
                <c:ptCount val="4"/>
                <c:pt idx="0">
                  <c:v>No HIV/ no drug</c:v>
                </c:pt>
                <c:pt idx="1">
                  <c:v>HIV/no drug</c:v>
                </c:pt>
                <c:pt idx="2">
                  <c:v>HIV+10ug fentanyl</c:v>
                </c:pt>
                <c:pt idx="3">
                  <c:v>HIV+10ug fentanyl+10ug naltrexone</c:v>
                </c:pt>
              </c:strCache>
            </c:strRef>
          </c:cat>
          <c:val>
            <c:numRef>
              <c:f>'Day 3 C37'!$I$14:$I$17</c:f>
              <c:numCache>
                <c:formatCode>General</c:formatCode>
                <c:ptCount val="4"/>
                <c:pt idx="0">
                  <c:v>5.5029382414636938</c:v>
                </c:pt>
                <c:pt idx="1">
                  <c:v>41.472234270939055</c:v>
                </c:pt>
                <c:pt idx="2">
                  <c:v>55.174823234548725</c:v>
                </c:pt>
                <c:pt idx="3">
                  <c:v>43.1850578913902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7B7-4164-8127-009537FC20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1243983"/>
        <c:axId val="1884350575"/>
      </c:barChart>
      <c:catAx>
        <c:axId val="14124398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1500000" spcFirstLastPara="1" vertOverflow="ellipsis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84350575"/>
        <c:crosses val="autoZero"/>
        <c:auto val="1"/>
        <c:lblAlgn val="ctr"/>
        <c:lblOffset val="100"/>
        <c:noMultiLvlLbl val="0"/>
      </c:catAx>
      <c:valAx>
        <c:axId val="1884350575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41243983"/>
        <c:crosses val="autoZero"/>
        <c:crossBetween val="between"/>
        <c:majorUnit val="20"/>
        <c:min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521867612063069"/>
          <c:y val="7.3878196074239774E-2"/>
          <c:w val="0.71529991677869531"/>
          <c:h val="0.4915912995014544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ontrol 37'!$I$18:$L$18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0764567560089577</c:v>
                  </c:pt>
                  <c:pt idx="2">
                    <c:v>0.2063581001145815</c:v>
                  </c:pt>
                  <c:pt idx="3">
                    <c:v>8.6205872991588967E-2</c:v>
                  </c:pt>
                </c:numCache>
              </c:numRef>
            </c:plus>
            <c:minus>
              <c:numRef>
                <c:f>'Control 37'!$I$18:$L$18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0764567560089577</c:v>
                  </c:pt>
                  <c:pt idx="2">
                    <c:v>0.2063581001145815</c:v>
                  </c:pt>
                  <c:pt idx="3">
                    <c:v>8.620587299158896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ontrol 37'!$I$16:$L$16</c:f>
              <c:strCache>
                <c:ptCount val="4"/>
                <c:pt idx="0">
                  <c:v>No HIV/ no drug</c:v>
                </c:pt>
                <c:pt idx="1">
                  <c:v>HIV/no drug</c:v>
                </c:pt>
                <c:pt idx="2">
                  <c:v>HIV+10ug fentanyl</c:v>
                </c:pt>
                <c:pt idx="3">
                  <c:v>HIV+10ug fentanyl+10ug naltrexone</c:v>
                </c:pt>
              </c:strCache>
            </c:strRef>
          </c:cat>
          <c:val>
            <c:numRef>
              <c:f>'Control 37'!$I$17:$L$17</c:f>
              <c:numCache>
                <c:formatCode>General</c:formatCode>
                <c:ptCount val="4"/>
                <c:pt idx="0">
                  <c:v>0</c:v>
                </c:pt>
                <c:pt idx="1">
                  <c:v>4.1284843702411376</c:v>
                </c:pt>
                <c:pt idx="2">
                  <c:v>5.6400856177800804</c:v>
                </c:pt>
                <c:pt idx="3">
                  <c:v>3.57639933457501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C02-4AEE-B353-7AC7D91CC7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48654064"/>
        <c:axId val="1548653232"/>
      </c:barChart>
      <c:catAx>
        <c:axId val="15486540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95000"/>
                <a:lumOff val="5000"/>
              </a:schemeClr>
            </a:solidFill>
            <a:round/>
          </a:ln>
          <a:effectLst/>
        </c:spPr>
        <c:txPr>
          <a:bodyPr rot="-1500000" spcFirstLastPara="1" vertOverflow="ellipsis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48653232"/>
        <c:crosses val="autoZero"/>
        <c:auto val="1"/>
        <c:lblAlgn val="ctr"/>
        <c:lblOffset val="100"/>
        <c:noMultiLvlLbl val="0"/>
      </c:catAx>
      <c:valAx>
        <c:axId val="15486532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>
                <a:lumMod val="95000"/>
                <a:lumOff val="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48654064"/>
        <c:crosses val="autoZero"/>
        <c:crossBetween val="between"/>
        <c:majorUnit val="1"/>
        <c:min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 b="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7918</cdr:x>
      <cdr:y>0</cdr:y>
    </cdr:from>
    <cdr:to>
      <cdr:x>0.13126</cdr:x>
      <cdr:y>0.56754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E865C1D8-282D-4780-8A65-FCD40EC6FDA9}"/>
            </a:ext>
          </a:extLst>
        </cdr:cNvPr>
        <cdr:cNvSpPr txBox="1"/>
      </cdr:nvSpPr>
      <cdr:spPr>
        <a:xfrm xmlns:a="http://schemas.openxmlformats.org/drawingml/2006/main" rot="16200000">
          <a:off x="-420409" y="863398"/>
          <a:ext cx="2018187" cy="29139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marL="0" marR="0" lvl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n-US" sz="1200" b="0" i="0" baseline="0" dirty="0"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HIV p24 (</a:t>
          </a:r>
          <a:r>
            <a:rPr lang="en-US" sz="1200" b="0" i="0" baseline="0" dirty="0" err="1"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pg</a:t>
          </a:r>
          <a:r>
            <a:rPr lang="en-US" sz="1200" b="0" i="0" baseline="0" dirty="0"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/mL)</a:t>
          </a:r>
          <a:endParaRPr lang="en-US" sz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7851</cdr:x>
      <cdr:y>0</cdr:y>
    </cdr:from>
    <cdr:to>
      <cdr:x>0.16667</cdr:x>
      <cdr:y>0.64194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7A2B07ED-FEB2-0D3D-168F-4DB68F46D945}"/>
            </a:ext>
          </a:extLst>
        </cdr:cNvPr>
        <cdr:cNvSpPr txBox="1"/>
      </cdr:nvSpPr>
      <cdr:spPr>
        <a:xfrm xmlns:a="http://schemas.openxmlformats.org/drawingml/2006/main" rot="16200000">
          <a:off x="-398466" y="851615"/>
          <a:ext cx="2212109" cy="50887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US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DNA proviral load</a:t>
          </a:r>
        </a:p>
        <a:p xmlns:a="http://schemas.openxmlformats.org/drawingml/2006/main">
          <a:pPr algn="ctr"/>
          <a:r>
            <a:rPr lang="en-US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(log copies / 1 × 10</a:t>
          </a:r>
          <a:r>
            <a:rPr lang="en-US" sz="1200" baseline="30000" dirty="0">
              <a:latin typeface="Times New Roman" panose="02020603050405020304" pitchFamily="18" charset="0"/>
              <a:cs typeface="Times New Roman" panose="02020603050405020304" pitchFamily="18" charset="0"/>
            </a:rPr>
            <a:t>5</a:t>
          </a:r>
          <a:r>
            <a:rPr lang="en-US" sz="1200" baseline="0" dirty="0">
              <a:latin typeface="Times New Roman" panose="02020603050405020304" pitchFamily="18" charset="0"/>
              <a:cs typeface="Times New Roman" panose="02020603050405020304" pitchFamily="18" charset="0"/>
            </a:rPr>
            <a:t>cells</a:t>
          </a:r>
          <a:r>
            <a:rPr lang="en-US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)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83296E-07C4-4B51-BEAC-5B5FAB6B6FE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0CDE5AE-C486-4F66-A222-3A8B14E1256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CB77C8-9C58-4568-9F3A-939F969800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50595-915B-45BF-85D0-491917A0C3C5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9FFFBA-5CBA-4F2B-919C-F1AE4B54EE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8390A3-659D-44DD-A3EE-B0258F293C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36023-0A42-4B4D-B484-3C62E870B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8500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DDA0B1-0612-48A5-8629-F929BFD432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E3D41C5-B412-475A-9378-C79FD4DB8D5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54CCCC-0B59-484D-9953-F09B55B7C4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50595-915B-45BF-85D0-491917A0C3C5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9FEFA7-897C-4A2B-A172-ECCB4ABC9C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AD9ED4-79C2-498A-AAEA-F2745EEE05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36023-0A42-4B4D-B484-3C62E870B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7565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3A9318E-7718-4C0C-BC81-4A0302213B5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9D474C6-E33A-4C72-8988-2F7BEE844F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BBF21F-DCC4-46E7-B90A-E89234A926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50595-915B-45BF-85D0-491917A0C3C5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364E4B-F6E5-4082-AA5E-B47F7DBFA3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1F0C5A-4319-4F7A-A31F-636D30B912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36023-0A42-4B4D-B484-3C62E870B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75284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07270A-5FA2-4D7B-9B8D-F3770D4CC2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677A337-2443-44B8-978D-9F5EC705F6D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5AD7C1-D7B0-47BD-BC38-F5BB03EACC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50595-915B-45BF-85D0-491917A0C3C5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F1E5F0-D78C-4A90-A260-595C5C8EFD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339AEF-9415-4629-92F1-E98C18D905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36023-0A42-4B4D-B484-3C62E870B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70933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86F1BB-FC82-4965-A5F5-A693E46F75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DD803D3-1EBC-4B0B-A02C-43DB0082DE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596069-B9E2-4845-9150-740493FB57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50595-915B-45BF-85D0-491917A0C3C5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DAB129-9F74-47B7-8C6E-4CE72B45D9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E66FC8-C68F-4B42-8F9A-8B2E8BEB9B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36023-0A42-4B4D-B484-3C62E870B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76355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0945BB-C323-4F3A-B832-F9E8C9191C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DB17F9F-80E0-4FDA-BEDB-41D0496CD3A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DE619DB-3CFD-472D-9E57-3688604AAD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D4D1CDD-9F5F-4B10-8803-849CCDF50E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50595-915B-45BF-85D0-491917A0C3C5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B5E1A76-363A-4012-A931-94ECA774B1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3C3BC87-82CB-4DC4-9D14-566401AE64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36023-0A42-4B4D-B484-3C62E870B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75953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B1F393-7884-4000-B4A0-894E581AC9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8B0701-4CC9-4803-9762-7A8F3AA160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1334F9A-C94E-4BE4-BFED-DDE9C9CD6B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2C0D28F-0751-4E56-81C1-0DD25BB02D5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FA4A50A-5389-49D6-94DC-07C175ACDA6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97BF77D-9BEE-4FE7-9D58-F69C128BFD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50595-915B-45BF-85D0-491917A0C3C5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4F7CD2A-1921-474C-9F1B-10EB79899F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D0F722A-6DE8-4D16-9F48-6AE89CFBC4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36023-0A42-4B4D-B484-3C62E870B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01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E0DB01-F886-47D4-8105-032F5AE06F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FBBEE99-8E3C-49DF-B687-C63F9F90A3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50595-915B-45BF-85D0-491917A0C3C5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91235A6-1341-4FAA-8C95-F5C25DAFC1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BAFC78E-1CA9-43E5-AA23-30773BD15F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36023-0A42-4B4D-B484-3C62E870B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939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95802D2-30D4-4143-B4B8-A1CEA9CB3D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50595-915B-45BF-85D0-491917A0C3C5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7E56FD7-49C4-4BA3-8428-A7E30F7A4F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D6671A6-C215-41E5-9116-518845769E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36023-0A42-4B4D-B484-3C62E870B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74319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823C22-1F23-4758-B20A-36F2D0C29B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6BEDA1-9541-4310-8D0E-D56D776B9F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8EF863D-C646-43F2-A6D6-A3B4EE31E7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30A2CB6-05ED-4FE2-9279-9F47F686B1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50595-915B-45BF-85D0-491917A0C3C5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074DE6E-B2A5-4CA9-BDE2-0A6A55DE06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92C69A-DE70-4CA4-A450-FF3AACE60E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36023-0A42-4B4D-B484-3C62E870B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17294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95C904-8DBD-4376-A4F3-9ACAF96EB8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511F9E2-CC4B-4BF1-BD55-D48D0A99EB1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6F1845A-7634-4985-9828-577D32CF19C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FB6E8E-E54D-461B-8C4B-D1E48D0A95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550595-915B-45BF-85D0-491917A0C3C5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16676E-7473-4DB4-9454-1E2801D26F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D43C9B2-6DB8-41F0-AC87-F21B55EB1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936023-0A42-4B4D-B484-3C62E870B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4745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1CF0321-E93D-486F-9A4C-437822AB80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22FDEBD-A24F-4BDF-8205-1CA1F8E536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111E82-D705-4F8B-B8A5-61B815D9B1F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550595-915B-45BF-85D0-491917A0C3C5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F01BAA-1467-46E8-9280-532021DA138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0C23AC-9A0A-4727-B57D-71389A71981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936023-0A42-4B4D-B484-3C62E870B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50070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41AD49A-1C97-48D1-9EF3-B475223395BF}"/>
              </a:ext>
            </a:extLst>
          </p:cNvPr>
          <p:cNvSpPr txBox="1"/>
          <p:nvPr/>
        </p:nvSpPr>
        <p:spPr>
          <a:xfrm>
            <a:off x="10765766" y="88636"/>
            <a:ext cx="11818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ontrol ID : 37</a:t>
            </a:r>
          </a:p>
        </p:txBody>
      </p:sp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AAB57179-6645-41A8-AF74-F807E683A18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90359521"/>
              </p:ext>
            </p:extLst>
          </p:nvPr>
        </p:nvGraphicFramePr>
        <p:xfrm>
          <a:off x="5863105" y="1535896"/>
          <a:ext cx="5595056" cy="35559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8C9DB45E-1755-4B33-B35E-2836FFACA1C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58230827"/>
              </p:ext>
            </p:extLst>
          </p:nvPr>
        </p:nvGraphicFramePr>
        <p:xfrm>
          <a:off x="177219" y="1483622"/>
          <a:ext cx="5772150" cy="34459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F39602F5-79C1-4376-9377-27E1F7C1D53D}"/>
              </a:ext>
            </a:extLst>
          </p:cNvPr>
          <p:cNvSpPr txBox="1"/>
          <p:nvPr/>
        </p:nvSpPr>
        <p:spPr>
          <a:xfrm>
            <a:off x="0" y="5842337"/>
            <a:ext cx="1219200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4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: PBMC derived </a:t>
            </a:r>
            <a:r>
              <a:rPr lang="en-US" sz="1200" dirty="0">
                <a:latin typeface="Times New Roman" panose="02020603050405020304" pitchFamily="18" charset="0"/>
              </a:rPr>
              <a:t>CD4</a:t>
            </a:r>
            <a:r>
              <a:rPr lang="en-US" sz="1200" baseline="30000" dirty="0">
                <a:latin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T cells were seeded at ~1 × 10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5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ells per well. 10</a:t>
            </a:r>
            <a:r>
              <a:rPr lang="el-GR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g of naltrexone was added into the respective well and the cells are incubated for 24 hrs. After incubation cells were infected with HIV</a:t>
            </a:r>
            <a:r>
              <a:rPr lang="en-US" sz="1050" baseline="-25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L4-3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 at MOI of 1 for 2 hours and rinsed with RPMI + 10% FBS + 1% antibiotics (Pen/Strep) + 1% glutamine for three times to remove any unbound virus and replaced with fresh media. Fentanyl at concentration of 10ug/mL was added to the respective well and incubated. After incubation with drug and virus for 72 hours, HIV proviral DNA was quantified in cells by real-time PCR based on SYBR Green I detection and HIV p24 antigen expression was estimated from the cell culture supernatant. Error bar represents the standard deviations between the replicates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41061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7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SimSun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dhuravasal Krishnan, Janani (jananimk)</dc:creator>
  <cp:lastModifiedBy>Madhuravasal Krishnan, Janani (jananimk)</cp:lastModifiedBy>
  <cp:revision>1</cp:revision>
  <dcterms:created xsi:type="dcterms:W3CDTF">2024-06-12T20:07:24Z</dcterms:created>
  <dcterms:modified xsi:type="dcterms:W3CDTF">2024-07-11T18:37:49Z</dcterms:modified>
</cp:coreProperties>
</file>